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Arial"/>
                <a:ea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BA8039-862C-4BDF-8BEB-D8DD998D0B43}" type="slidenum">
              <a:rPr b="0" lang="ko-KR" sz="12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6DA1C9-34A4-4D23-8484-5FAA3DF2E0E1}" type="slidenum">
              <a:rPr b="0" lang="ko-KR" sz="12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Arial"/>
              <a:ea typeface="굴림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C3A76A-50BE-4455-81FA-04FCF44450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E8CA14-113D-421C-A05A-0F2DE8103F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43983E-C47B-481B-8007-6725307475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E9D5A8-95F0-4278-BFDF-8F9BA4D4B4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2D075D-D476-41FB-AD9D-523ED9CD81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6941C5-A4FE-497E-8A38-BF8B7B7FBA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A05864-F27D-4D49-BAA5-6E89669CAB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D72B00-D695-4F82-9772-F85516EEE7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EFF96C-0857-4833-88B3-99502D1F5A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E7477-9B35-40CC-8B55-CF3B99449D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3139CC-B109-40EC-ACAA-468A827304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D5C240-16C5-45D6-BCCB-E7E2CD04DA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Arial"/>
                <a:ea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CD106B-7FFE-4EFC-BD01-65DF0378D052}" type="slidenum">
              <a:rPr b="0" lang="ko-KR" sz="14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4"/>
          <p:cNvSpPr/>
          <p:nvPr/>
        </p:nvSpPr>
        <p:spPr>
          <a:xfrm>
            <a:off x="2465280" y="1638360"/>
            <a:ext cx="2865600" cy="641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gene has been reported to be methylated in multiple types  of  cancer including colon cancer (MGM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5"/>
          <p:cNvSpPr/>
          <p:nvPr/>
        </p:nvSpPr>
        <p:spPr>
          <a:xfrm>
            <a:off x="5932440" y="2819520"/>
            <a:ext cx="2286000" cy="641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23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genes that were methylated in CRC cell lines by bisulfite sequencing or C-MS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6"/>
          <p:cNvSpPr/>
          <p:nvPr/>
        </p:nvSpPr>
        <p:spPr>
          <a:xfrm>
            <a:off x="903240" y="2706840"/>
            <a:ext cx="2152800" cy="641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27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genes that were not methylated in CRC cell lines by bisulfite-sequencing or C-MS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7"/>
          <p:cNvSpPr/>
          <p:nvPr/>
        </p:nvSpPr>
        <p:spPr>
          <a:xfrm>
            <a:off x="3060720" y="3040200"/>
            <a:ext cx="609480" cy="56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8"/>
          <p:cNvSpPr/>
          <p:nvPr/>
        </p:nvSpPr>
        <p:spPr>
          <a:xfrm>
            <a:off x="5627520" y="1828800"/>
            <a:ext cx="2614680" cy="641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gene has been reported to be methylated in tumors other than colon cancer (NTRK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9"/>
          <p:cNvSpPr/>
          <p:nvPr/>
        </p:nvSpPr>
        <p:spPr>
          <a:xfrm>
            <a:off x="4218120" y="2298600"/>
            <a:ext cx="723600" cy="520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0"/>
          <p:cNvSpPr/>
          <p:nvPr/>
        </p:nvSpPr>
        <p:spPr>
          <a:xfrm flipH="1">
            <a:off x="5398560" y="3083040"/>
            <a:ext cx="546120" cy="12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Oval 11"/>
          <p:cNvSpPr/>
          <p:nvPr/>
        </p:nvSpPr>
        <p:spPr>
          <a:xfrm>
            <a:off x="3365640" y="2349360"/>
            <a:ext cx="2449440" cy="158436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2"/>
          <p:cNvSpPr/>
          <p:nvPr/>
        </p:nvSpPr>
        <p:spPr>
          <a:xfrm flipH="1">
            <a:off x="4373280" y="2378160"/>
            <a:ext cx="563400" cy="834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13"/>
          <p:cNvSpPr/>
          <p:nvPr/>
        </p:nvSpPr>
        <p:spPr>
          <a:xfrm>
            <a:off x="4373640" y="3213000"/>
            <a:ext cx="530280" cy="695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4"/>
          <p:cNvSpPr/>
          <p:nvPr/>
        </p:nvSpPr>
        <p:spPr>
          <a:xfrm>
            <a:off x="3655800" y="2938320"/>
            <a:ext cx="63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굴림"/>
              </a:rPr>
              <a:t>Un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5"/>
          <p:cNvSpPr/>
          <p:nvPr/>
        </p:nvSpPr>
        <p:spPr>
          <a:xfrm>
            <a:off x="4888080" y="2943360"/>
            <a:ext cx="37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굴림"/>
              </a:rPr>
              <a:t>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6"/>
          <p:cNvSpPr/>
          <p:nvPr/>
        </p:nvSpPr>
        <p:spPr>
          <a:xfrm>
            <a:off x="5832360" y="3860640"/>
            <a:ext cx="2386080" cy="641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gene has been reported to be methylated in colon cancer (SFRP4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7"/>
          <p:cNvSpPr/>
          <p:nvPr/>
        </p:nvSpPr>
        <p:spPr>
          <a:xfrm>
            <a:off x="3098880" y="4505400"/>
            <a:ext cx="2614680" cy="45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gene was counted twice because of two different NM numbers (SIRT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8"/>
          <p:cNvSpPr/>
          <p:nvPr/>
        </p:nvSpPr>
        <p:spPr>
          <a:xfrm flipV="1">
            <a:off x="4422600" y="3594240"/>
            <a:ext cx="522360" cy="915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19"/>
          <p:cNvSpPr/>
          <p:nvPr/>
        </p:nvSpPr>
        <p:spPr>
          <a:xfrm>
            <a:off x="6184800" y="2475000"/>
            <a:ext cx="457200" cy="414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0"/>
          <p:cNvSpPr/>
          <p:nvPr/>
        </p:nvSpPr>
        <p:spPr>
          <a:xfrm flipV="1">
            <a:off x="6261120" y="3409920"/>
            <a:ext cx="457200" cy="4636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1"/>
          <p:cNvSpPr/>
          <p:nvPr/>
        </p:nvSpPr>
        <p:spPr>
          <a:xfrm>
            <a:off x="533520" y="3657600"/>
            <a:ext cx="2614320" cy="641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gene has been reported to be methylated in tumors other than colon cancer (PLAU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2"/>
          <p:cNvSpPr/>
          <p:nvPr/>
        </p:nvSpPr>
        <p:spPr>
          <a:xfrm flipV="1">
            <a:off x="1841400" y="327672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23"/>
          <p:cNvSpPr/>
          <p:nvPr/>
        </p:nvSpPr>
        <p:spPr>
          <a:xfrm>
            <a:off x="6860160" y="0"/>
            <a:ext cx="226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Myoung S. Kim et al., 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29T15:45:24Z</dcterms:created>
  <dc:creator>mkim51</dc:creator>
  <dc:description/>
  <dc:language>en-US</dc:language>
  <cp:lastModifiedBy>mkim51</cp:lastModifiedBy>
  <dcterms:modified xsi:type="dcterms:W3CDTF">2009-07-08T18:06:17Z</dcterms:modified>
  <cp:revision>49</cp:revision>
  <dc:subject/>
  <dc:title>Slide 1</dc:title>
</cp:coreProperties>
</file>